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26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9FDDF-0A1B-42A8-BFAA-1BFFD6F9330D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81CCF-59F6-4571-8C98-60FC0CB410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16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495300" y="-587375"/>
            <a:ext cx="9147175" cy="26193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3864278"/>
              </p:ext>
            </p:extLst>
          </p:nvPr>
        </p:nvGraphicFramePr>
        <p:xfrm>
          <a:off x="457200" y="533400"/>
          <a:ext cx="7315200" cy="6172188"/>
        </p:xfrm>
        <a:graphic>
          <a:graphicData uri="http://schemas.openxmlformats.org/drawingml/2006/table">
            <a:tbl>
              <a:tblPr firstRow="1"/>
              <a:tblGrid>
                <a:gridCol w="702744"/>
                <a:gridCol w="2744336"/>
                <a:gridCol w="3095708"/>
                <a:gridCol w="772412"/>
              </a:tblGrid>
              <a:tr h="42567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arker </a:t>
                      </a:r>
                      <a:endParaRPr lang="en-US" sz="1100" b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Forward primer</a:t>
                      </a:r>
                      <a:endParaRPr lang="en-US" sz="1100" b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Reverse primer</a:t>
                      </a:r>
                      <a:endParaRPr lang="en-US" sz="1100" b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roduct size (</a:t>
                      </a:r>
                      <a:r>
                        <a:rPr lang="en-US" sz="1050" b="1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bp</a:t>
                      </a:r>
                      <a:r>
                        <a:rPr lang="en-US" sz="105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 </a:t>
                      </a:r>
                      <a:endParaRPr lang="en-US" sz="1100" b="1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1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GAAATGGGATGGGAGAAG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CTTGGCCAGCTAGGATGT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90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2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GGTAGCAACAAGACAA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GCATGTTTAATGCTG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78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3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ACCTGCGTGCTTGTTGAT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AACCGGTTGAGCTGTTTT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38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4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GGCTGGTGTTATGTTTG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GTTAAGCTTTGACCACAC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2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5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GCTGATGTGGACACCAAG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TGCCACGAGATTTTCTACT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2</a:t>
                      </a:r>
                      <a:endParaRPr lang="en-US" sz="10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6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GCGAGCAGAAGTATAATC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GCGATCTCGCTACCTCTA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9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7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CTAGGCCGGGATATGT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TGTTGTTACGCGCACTA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9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8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CCCCATCAGTTGCTTATG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AGCACCATGGAGTCCCAT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90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09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TAGAGGTCGTCGGGAGGA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ATGCGTAAGGCTTCTGG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39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0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TACCCGCCTGCAAGAATT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TTCTGAACAACCACCAC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60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1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GGAAATGTCCAGCTTC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GCGTTACTTCGTAGTGGT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0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2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CGAAGATCAGCCTCCTAG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CAACCAAGTCCACGCTAA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3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3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CTGTCCTGGAGCCCTAG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CCATGTGTGCAGTGCTAA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8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4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AGTGTCTCACGGTCTCAC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AGAATGGATTCCGGATG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5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5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CTGAACCTCTCGGGCTTA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TACTGCCTCCTCCCTCCT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3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6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CGGGAACAGTAGGAGAG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GTTTCTCTGCCGCTTTC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79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7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GACGGAGGGAGTACTTTTG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TGTGGCAAGGGTGGATA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85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8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CTGTGGCTCTAGTGGGAA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TCTTCATGTTGCACATTTG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3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19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CAACGCACGGACATTT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GTATAAACCTCCGGGGAA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3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0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CACGCAGGTCAGGATTAC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GGTTCCTGCTCTGCTTC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16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1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AGAGACTGGTGTGGACTG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GGAGCTCAACACAAGAAC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65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2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TTGAGATGATCGGGCTCTT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CACAGTGGAAATTCGCTT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54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3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GGTGTAGAGATTGGCTTCC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CAAAATCTGGGGTTAGTG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96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4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GAAGCCTAAAAGTTTCAC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GAGTCAAAAAGTGAAGGGCAT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94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5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GCCTATCGTTCGTTTTC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ATCATGTCCACGCAATTCA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19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6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ATCAATACAAAGGCGGCA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TGGTTCAGATGCACCATAAA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68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283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A27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CGCGCGTGTATTATATTTG</a:t>
                      </a: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TGCATTTGGACGATCCTG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Times New Roman"/>
                        </a:rPr>
                        <a:t> </a:t>
                      </a:r>
                      <a:endParaRPr lang="en-US" sz="10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45</a:t>
                      </a:r>
                      <a:endParaRPr lang="en-US" sz="1000" dirty="0">
                        <a:effectLst/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59271" marR="5927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Rectangle 2"/>
          <p:cNvSpPr>
            <a:spLocks noChangeArrowheads="1"/>
          </p:cNvSpPr>
          <p:nvPr/>
        </p:nvSpPr>
        <p:spPr bwMode="auto">
          <a:xfrm>
            <a:off x="381000" y="209550"/>
            <a:ext cx="5557932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100" b="1" dirty="0" smtClean="0">
                <a:latin typeface="Times New Roman" pitchFamily="18" charset="0"/>
                <a:cs typeface="Arial" pitchFamily="34" charset="0"/>
              </a:rPr>
              <a:t>Additional file 11: Table</a:t>
            </a:r>
            <a:r>
              <a:rPr kumimoji="0" lang="en-US" alt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1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List of newly designed InDel markers </a:t>
            </a:r>
            <a:r>
              <a:rPr kumimoji="0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or fine mapping of </a:t>
            </a:r>
            <a:r>
              <a:rPr kumimoji="0" lang="en-US" altLang="ko-KR" sz="11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PH31</a:t>
            </a:r>
            <a:endParaRPr kumimoji="0" lang="en-US" altLang="ko-KR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2248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135</Words>
  <Application>Microsoft Office PowerPoint</Application>
  <PresentationFormat>On-screen Show (4:3)</PresentationFormat>
  <Paragraphs>1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DPrahalada</dc:creator>
  <cp:lastModifiedBy>Balindan, Danica Joy</cp:lastModifiedBy>
  <cp:revision>32</cp:revision>
  <dcterms:created xsi:type="dcterms:W3CDTF">2016-10-22T05:16:24Z</dcterms:created>
  <dcterms:modified xsi:type="dcterms:W3CDTF">2017-08-15T05:47:21Z</dcterms:modified>
</cp:coreProperties>
</file>